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5" d="100"/>
          <a:sy n="75" d="100"/>
        </p:scale>
        <p:origin x="678" y="7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1227D-0693-4E4E-9936-2BC8DFC03A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BD11A7-7BEA-4203-B36D-5745C271BD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FADA00-C9C5-413C-BBF6-51025D261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53E974-AF4A-4B98-900B-A516D6B5D6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675CBF-30E3-4C48-AC5F-07D494F03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308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E35EEB-BF4D-4DC7-A35C-421F9BBF13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45F1AA-E7F8-43A5-B300-76D6CD56CC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862DE5-75A6-4E8A-AB80-598F7F115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26632-57D8-4EB2-BB2D-DC41BF082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577415-67AD-4741-9684-7BF86B153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923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E57186-044D-400B-BDCB-B5F8E315A0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68F145-8297-414D-9AEA-DE8FD8AD32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E91C48-069B-418C-8481-485493606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D6B1B8-C43A-4ECC-AC54-5BCA6328A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18F15E-6B0A-4398-AAD6-EC5AADEDE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695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D8517E-6142-445D-A809-A06C7235A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C17076-AAC4-4DD9-AA06-B14C62FB89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A5451-72CD-4057-811A-263AB6EA7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F1ACBF-F6C7-4F55-AB2D-DC28775798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107939-47BD-4F9B-92ED-EC482DDAA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175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0DF2F-DECD-40BE-A53C-A0D2552D45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5D6630-632D-4605-B276-8C6201163B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CFBF08-5E11-4C43-968D-5649A23F8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6F61F2-98ED-4F16-8AE9-ECAB87AE4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00C3FD-8503-4D54-A96E-ECC102C40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755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943BA9-6E7D-49B5-876A-89E7278EE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013D53-A278-4A82-8173-E34006FD50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769719-D878-4AA5-A268-A888BC9377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A92C83-2F41-4E33-B390-379DF7E9D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DDE70-E7B8-4395-9E93-265A1496D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83AC05-F99C-4143-96A8-13F39E3B3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406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15CC08-FA66-417E-BE5C-370AFE58FC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662F3A-8AB5-4D6C-ADF0-0DDA93E7F1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9451D8-D4B8-459A-A5E6-C0C3DDACAC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40E045-3716-4AA6-B482-C33136E014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69A61D-8DF5-4C9D-B600-D360C501FE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20ADA1D-E82D-47B4-A9F5-E4E0DCF1E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AEA3CFE-9642-448C-BEBB-1324A1362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BDB9D0-32A9-4071-80AF-F8C5E5B18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686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894F5-C58A-414E-8E2E-C98AAFC93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13B0F3-5748-439D-A59B-A99CF712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95241CE-51AA-47DF-BFD3-ED48DEAC4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ECFBD4-4B18-4A3D-8F7E-DD249FD5C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326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F0545E-44B1-4816-81F9-F90D273CF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CA2438-EC34-424B-953B-3814A6D1B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4EBF99-1A2A-483F-8640-BE12AA371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184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4F5C83-BC33-4FF9-A27A-450A82B6B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9815A4-FE5C-4A67-BD47-236907029C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6041B0-1A89-401E-9585-7575C07E71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7B6D83-2D6F-4656-AB18-99D4E00CC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E19033-4B81-4F93-9924-B672EAF0D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E8D372-0DEA-483B-A6BD-ACB7C9367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436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2D52A-CAB0-42D6-A802-D576244D1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B3EE02A-D086-4071-960E-4B1054F261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CC06D1-EB08-4C8C-9DC3-A01F0BE62C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50DBF5-508B-4B03-BBF2-0BB885F0C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2332AC-0D91-4CF7-B693-08F6B7CA2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7EF198-61F6-44D0-82DC-211BD97A3F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96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A83FF9-EADC-41B9-93FD-6E06E474E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06D136-FB27-48E6-8413-373D7B0846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9F768A-152A-457F-8BF0-D2A66BB101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1281A-34D4-4BEC-B4FD-0E54C0E19308}" type="datetimeFigureOut">
              <a:rPr lang="en-US" smtClean="0"/>
              <a:t>6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1BFF2C-55FC-4CD3-B198-1B40FBB3D0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64E8EB-A3BB-40E7-A01A-5B037DA893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EA37DF-90B7-4ED9-A4E1-2688092C8E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434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avi"/><Relationship Id="rId13" Type="http://schemas.openxmlformats.org/officeDocument/2006/relationships/image" Target="../media/image2.png"/><Relationship Id="rId3" Type="http://schemas.microsoft.com/office/2007/relationships/media" Target="../media/media2.avi"/><Relationship Id="rId7" Type="http://schemas.microsoft.com/office/2007/relationships/media" Target="../media/media4.avi"/><Relationship Id="rId12" Type="http://schemas.openxmlformats.org/officeDocument/2006/relationships/image" Target="../media/image1.png"/><Relationship Id="rId2" Type="http://schemas.openxmlformats.org/officeDocument/2006/relationships/video" Target="../media/media1.avi"/><Relationship Id="rId16" Type="http://schemas.openxmlformats.org/officeDocument/2006/relationships/image" Target="../media/image5.png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openxmlformats.org/officeDocument/2006/relationships/slideLayout" Target="../slideLayouts/slideLayout1.xml"/><Relationship Id="rId5" Type="http://schemas.microsoft.com/office/2007/relationships/media" Target="../media/media3.avi"/><Relationship Id="rId15" Type="http://schemas.openxmlformats.org/officeDocument/2006/relationships/image" Target="../media/image4.png"/><Relationship Id="rId10" Type="http://schemas.openxmlformats.org/officeDocument/2006/relationships/video" Target="../media/media5.avi"/><Relationship Id="rId4" Type="http://schemas.openxmlformats.org/officeDocument/2006/relationships/video" Target="../media/media2.avi"/><Relationship Id="rId9" Type="http://schemas.microsoft.com/office/2007/relationships/media" Target="../media/media5.avi"/><Relationship Id="rId1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Table 23">
            <a:extLst>
              <a:ext uri="{FF2B5EF4-FFF2-40B4-BE49-F238E27FC236}">
                <a16:creationId xmlns:a16="http://schemas.microsoft.com/office/drawing/2014/main" id="{3B7EF5C4-3EA6-49A5-ACA8-CEFB8FFB3E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1011270"/>
              </p:ext>
            </p:extLst>
          </p:nvPr>
        </p:nvGraphicFramePr>
        <p:xfrm>
          <a:off x="288657" y="1595506"/>
          <a:ext cx="11507860" cy="21031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01572">
                  <a:extLst>
                    <a:ext uri="{9D8B030D-6E8A-4147-A177-3AD203B41FA5}">
                      <a16:colId xmlns:a16="http://schemas.microsoft.com/office/drawing/2014/main" val="3926795326"/>
                    </a:ext>
                  </a:extLst>
                </a:gridCol>
                <a:gridCol w="2301572">
                  <a:extLst>
                    <a:ext uri="{9D8B030D-6E8A-4147-A177-3AD203B41FA5}">
                      <a16:colId xmlns:a16="http://schemas.microsoft.com/office/drawing/2014/main" val="867440001"/>
                    </a:ext>
                  </a:extLst>
                </a:gridCol>
                <a:gridCol w="2301572">
                  <a:extLst>
                    <a:ext uri="{9D8B030D-6E8A-4147-A177-3AD203B41FA5}">
                      <a16:colId xmlns:a16="http://schemas.microsoft.com/office/drawing/2014/main" val="2802821178"/>
                    </a:ext>
                  </a:extLst>
                </a:gridCol>
                <a:gridCol w="2301572">
                  <a:extLst>
                    <a:ext uri="{9D8B030D-6E8A-4147-A177-3AD203B41FA5}">
                      <a16:colId xmlns:a16="http://schemas.microsoft.com/office/drawing/2014/main" val="1106925947"/>
                    </a:ext>
                  </a:extLst>
                </a:gridCol>
                <a:gridCol w="2301572">
                  <a:extLst>
                    <a:ext uri="{9D8B030D-6E8A-4147-A177-3AD203B41FA5}">
                      <a16:colId xmlns:a16="http://schemas.microsoft.com/office/drawing/2014/main" val="2177586571"/>
                    </a:ext>
                  </a:extLst>
                </a:gridCol>
              </a:tblGrid>
              <a:tr h="310206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46311219"/>
                  </a:ext>
                </a:extLst>
              </a:tr>
              <a:tr h="1150688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3418422"/>
                  </a:ext>
                </a:extLst>
              </a:tr>
            </a:tbl>
          </a:graphicData>
        </a:graphic>
      </p:graphicFrame>
      <p:pic>
        <p:nvPicPr>
          <p:cNvPr id="5" name="Video 4">
            <a:hlinkClick r:id="" action="ppaction://media"/>
            <a:extLst>
              <a:ext uri="{FF2B5EF4-FFF2-40B4-BE49-F238E27FC236}">
                <a16:creationId xmlns:a16="http://schemas.microsoft.com/office/drawing/2014/main" id="{8E83CF92-2AA4-4B8E-98FB-1CC91D1D13F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369843" y="2011938"/>
            <a:ext cx="2161107" cy="1646596"/>
          </a:xfrm>
          <a:prstGeom prst="rect">
            <a:avLst/>
          </a:prstGeom>
        </p:spPr>
      </p:pic>
      <p:pic>
        <p:nvPicPr>
          <p:cNvPr id="7" name="Video 6">
            <a:hlinkClick r:id="" action="ppaction://media"/>
            <a:extLst>
              <a:ext uri="{FF2B5EF4-FFF2-40B4-BE49-F238E27FC236}">
                <a16:creationId xmlns:a16="http://schemas.microsoft.com/office/drawing/2014/main" id="{793792AF-6E1F-4DA5-AB41-7F5E25C49E4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2661577" y="2011938"/>
            <a:ext cx="2161107" cy="1646596"/>
          </a:xfrm>
          <a:prstGeom prst="rect">
            <a:avLst/>
          </a:prstGeom>
        </p:spPr>
      </p:pic>
      <p:pic>
        <p:nvPicPr>
          <p:cNvPr id="9" name="Video 8">
            <a:hlinkClick r:id="" action="ppaction://media"/>
            <a:extLst>
              <a:ext uri="{FF2B5EF4-FFF2-40B4-BE49-F238E27FC236}">
                <a16:creationId xmlns:a16="http://schemas.microsoft.com/office/drawing/2014/main" id="{1B8D004A-ADC8-4780-B8B2-3C87AF744DB2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4"/>
          <a:stretch>
            <a:fillRect/>
          </a:stretch>
        </p:blipFill>
        <p:spPr>
          <a:xfrm>
            <a:off x="4978949" y="2011938"/>
            <a:ext cx="2161107" cy="1646596"/>
          </a:xfrm>
          <a:prstGeom prst="rect">
            <a:avLst/>
          </a:prstGeom>
        </p:spPr>
      </p:pic>
      <p:pic>
        <p:nvPicPr>
          <p:cNvPr id="11" name="Video 10">
            <a:hlinkClick r:id="" action="ppaction://media"/>
            <a:extLst>
              <a:ext uri="{FF2B5EF4-FFF2-40B4-BE49-F238E27FC236}">
                <a16:creationId xmlns:a16="http://schemas.microsoft.com/office/drawing/2014/main" id="{9CBCFBBD-C12C-46FA-8FFC-58F1BD7E24D6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7270683" y="2011938"/>
            <a:ext cx="2161107" cy="1646596"/>
          </a:xfrm>
          <a:prstGeom prst="rect">
            <a:avLst/>
          </a:prstGeom>
        </p:spPr>
      </p:pic>
      <p:pic>
        <p:nvPicPr>
          <p:cNvPr id="13" name="Video 12">
            <a:hlinkClick r:id="" action="ppaction://media"/>
            <a:extLst>
              <a:ext uri="{FF2B5EF4-FFF2-40B4-BE49-F238E27FC236}">
                <a16:creationId xmlns:a16="http://schemas.microsoft.com/office/drawing/2014/main" id="{063A97B8-FC5E-436E-8A77-A34F2A44FDED}"/>
              </a:ext>
            </a:extLst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16"/>
          <a:stretch>
            <a:fillRect/>
          </a:stretch>
        </p:blipFill>
        <p:spPr>
          <a:xfrm>
            <a:off x="9562417" y="2011938"/>
            <a:ext cx="2161107" cy="164659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744A790-5409-4F77-B907-9280A6F09C89}"/>
              </a:ext>
            </a:extLst>
          </p:cNvPr>
          <p:cNvSpPr txBox="1"/>
          <p:nvPr/>
        </p:nvSpPr>
        <p:spPr>
          <a:xfrm>
            <a:off x="557852" y="1643757"/>
            <a:ext cx="1947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n-treated group (Normal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10CEC9B-0B16-4685-9DAE-8B680FE66821}"/>
              </a:ext>
            </a:extLst>
          </p:cNvPr>
          <p:cNvSpPr txBox="1"/>
          <p:nvPr/>
        </p:nvSpPr>
        <p:spPr>
          <a:xfrm>
            <a:off x="2781221" y="1643756"/>
            <a:ext cx="20671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xamethasone/saline grou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F29F8D6-F527-41C1-B40A-DE836F0AD2F6}"/>
              </a:ext>
            </a:extLst>
          </p:cNvPr>
          <p:cNvSpPr txBox="1"/>
          <p:nvPr/>
        </p:nvSpPr>
        <p:spPr>
          <a:xfrm>
            <a:off x="5286155" y="1643756"/>
            <a:ext cx="16607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x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/0.3% maca grou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C8262BC-EE19-4674-938B-5EBEC5865BBE}"/>
              </a:ext>
            </a:extLst>
          </p:cNvPr>
          <p:cNvSpPr txBox="1"/>
          <p:nvPr/>
        </p:nvSpPr>
        <p:spPr>
          <a:xfrm>
            <a:off x="7608100" y="1643755"/>
            <a:ext cx="194767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x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/1% maca grou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485A0C2-3228-4A40-86C7-5EED1A228650}"/>
              </a:ext>
            </a:extLst>
          </p:cNvPr>
          <p:cNvSpPr txBox="1"/>
          <p:nvPr/>
        </p:nvSpPr>
        <p:spPr>
          <a:xfrm>
            <a:off x="9886877" y="1643755"/>
            <a:ext cx="16607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1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ex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/3% maca grou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95066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019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8019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7993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1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7993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3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799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15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 mute="1">
                <p:cTn id="21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 mute="1">
                <p:cTn id="27" repeatCount="indefinite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28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9" fill="hold">
                      <p:stCondLst>
                        <p:cond delay="0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2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 mute="1">
                <p:cTn id="33" repeatCount="indefinite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34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5" fill="hold">
                      <p:stCondLst>
                        <p:cond delay="0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8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 mute="1">
                <p:cTn id="39" repeatCount="indefinite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seq concurrent="1" nextAc="seek">
              <p:cTn id="40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1" fill="hold">
                      <p:stCondLst>
                        <p:cond delay="0"/>
                      </p:stCondLst>
                      <p:childTnLst>
                        <p:par>
                          <p:cTn id="42" fill="hold">
                            <p:stCondLst>
                              <p:cond delay="0"/>
                            </p:stCondLst>
                            <p:childTnLst>
                              <p:par>
                                <p:cTn id="43" presetID="2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4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7</Words>
  <Application>Microsoft Office PowerPoint</Application>
  <PresentationFormat>Widescreen</PresentationFormat>
  <Paragraphs>9</Paragraphs>
  <Slides>1</Slides>
  <Notes>0</Notes>
  <HiddenSlides>0</HiddenSlides>
  <MMClips>5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u BoMi</dc:creator>
  <cp:lastModifiedBy>Ryu BoMi</cp:lastModifiedBy>
  <cp:revision>4</cp:revision>
  <dcterms:created xsi:type="dcterms:W3CDTF">2021-06-17T10:11:29Z</dcterms:created>
  <dcterms:modified xsi:type="dcterms:W3CDTF">2021-06-17T13:18:38Z</dcterms:modified>
</cp:coreProperties>
</file>